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0" r:id="rId3"/>
    <p:sldId id="259" r:id="rId4"/>
    <p:sldId id="25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79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71E569-7C74-DFC6-28FC-2F87CD36686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94CAC7B-1ACC-287B-355F-DF98683099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8F4B5B-60C1-7A00-9A90-C64B59F09E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2068D-A75F-474F-B16C-DE4D13AE3CF1}" type="datetimeFigureOut">
              <a:rPr lang="en-US" smtClean="0"/>
              <a:t>2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A15E98-8550-1015-7E31-26BE968602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34C4DD-5D28-CBE8-E6AF-4608435515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4B1AE-7F45-4D2D-A34F-DA245737C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58418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F6FF4D-804E-7769-42CF-DC2D59A796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1755FED-CCDD-F984-CCE9-90D0774EAA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A1A4CD-0F8C-4F8F-C21F-C370E92014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2068D-A75F-474F-B16C-DE4D13AE3CF1}" type="datetimeFigureOut">
              <a:rPr lang="en-US" smtClean="0"/>
              <a:t>2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6F7CE3-B736-A62D-11AE-DD024F8440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623CD7-D251-37FE-07DC-F2A332EABA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4B1AE-7F45-4D2D-A34F-DA245737C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3774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DA80DDC-E028-872D-7CE7-15A0745758F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2B513FC-5CD7-C598-27C0-AA2012A1C9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A66F3D-27BB-1E45-1BC2-A63CA8A256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2068D-A75F-474F-B16C-DE4D13AE3CF1}" type="datetimeFigureOut">
              <a:rPr lang="en-US" smtClean="0"/>
              <a:t>2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0A9EED-B0FC-95D8-0438-1F9B339C35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977FBE-A7DB-757F-C572-02C0623D03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4B1AE-7F45-4D2D-A34F-DA245737C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24455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FE4BF2-DC0B-8A9B-08B8-4BCA76428E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E6ED2A-E12C-CFB9-7F94-8491F8922FA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DDAFA4-D391-E966-4D7B-3B7ACF8CD5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2068D-A75F-474F-B16C-DE4D13AE3CF1}" type="datetimeFigureOut">
              <a:rPr lang="en-US" smtClean="0"/>
              <a:t>2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012C14-09B5-A00F-FA7C-CC0D700C3A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48EA91-5218-ABB7-3596-B6F0455805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4B1AE-7F45-4D2D-A34F-DA245737C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72991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6570D2-6866-1A58-86B6-498D892B0A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B00AD3F-7388-6CC7-22AC-3FEB5CBCC9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B12FD6-2F08-9A8E-3FF5-400355F3CC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2068D-A75F-474F-B16C-DE4D13AE3CF1}" type="datetimeFigureOut">
              <a:rPr lang="en-US" smtClean="0"/>
              <a:t>2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775333-7B64-05AF-965A-322B01C41E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39B8C6-7BE3-CE34-F878-EBCC151407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4B1AE-7F45-4D2D-A34F-DA245737C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50581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81966E-E427-15E2-AEBD-8D2C4005BD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62B142-D893-DD0E-385B-976DF6512F6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BB5C609-ECB6-2FAD-5EF2-E6AFFCC172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736C05-56BB-23C4-833B-09448A4E52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2068D-A75F-474F-B16C-DE4D13AE3CF1}" type="datetimeFigureOut">
              <a:rPr lang="en-US" smtClean="0"/>
              <a:t>2/1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0DAEB2-BB1C-1F4F-3FAD-BCEF1300C2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46B078-4771-E691-D87E-E80EA46276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4B1AE-7F45-4D2D-A34F-DA245737C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76002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BF6DFA-E3D4-56CE-7CB7-2112A5A417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6AD822D-DFB7-342D-9B7F-A97DFB5323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478DBBE-139A-0F2C-0309-DF88F25A78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53EC22C-DD1F-C813-ACAD-633F988902C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CB25804-1F7D-8878-65D1-15081E7BC92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F7A9326-0B75-7F8B-99B0-337FF7D054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2068D-A75F-474F-B16C-DE4D13AE3CF1}" type="datetimeFigureOut">
              <a:rPr lang="en-US" smtClean="0"/>
              <a:t>2/19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EB42EF1-BDB1-A606-D941-569DB94DFF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552C6E3-48DA-4FF3-9439-69365780A8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4B1AE-7F45-4D2D-A34F-DA245737C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95891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C9ED3F-47E2-E4EA-93E3-CBA7EA95B8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BD6D8E2-9480-D4F2-98EC-6493399867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2068D-A75F-474F-B16C-DE4D13AE3CF1}" type="datetimeFigureOut">
              <a:rPr lang="en-US" smtClean="0"/>
              <a:t>2/19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690C73B-F7EE-BF37-FEFA-ED60AC5EC2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9E9CA20-7214-6A2A-6D2D-1C6FD87A7B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4B1AE-7F45-4D2D-A34F-DA245737C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90962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6789B86-EAEE-93F9-C63F-A186C3FF1A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2068D-A75F-474F-B16C-DE4D13AE3CF1}" type="datetimeFigureOut">
              <a:rPr lang="en-US" smtClean="0"/>
              <a:t>2/19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3A07480-8E68-75D4-CAE0-AD4989D5E0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E6B5D95-D547-A707-66A5-E282B07215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4B1AE-7F45-4D2D-A34F-DA245737C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90829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48A11F-77BA-CC33-7EC6-719D098315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9CA165-10CB-85AA-ADFA-E9DA8D60575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4B51F1E-488B-CC50-7C9E-FA69C24294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23425A-085E-C3DC-C31C-38F31B3A16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2068D-A75F-474F-B16C-DE4D13AE3CF1}" type="datetimeFigureOut">
              <a:rPr lang="en-US" smtClean="0"/>
              <a:t>2/1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C8B886-7D1E-99A1-A085-9584BFD152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38380FD-1B8B-0F57-8BBA-DFCF43680E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4B1AE-7F45-4D2D-A34F-DA245737C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98922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C6F0E9-D874-E650-B9FF-6DAD9CD640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3A0FA42-E70E-8AF5-A180-02389955E58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2AF2E4A-ADB0-7CC1-CCDB-0547DC73AA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53D6FB1-335F-8E96-2840-65AD0C68C8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2068D-A75F-474F-B16C-DE4D13AE3CF1}" type="datetimeFigureOut">
              <a:rPr lang="en-US" smtClean="0"/>
              <a:t>2/1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E8411C-E0E1-E73F-B577-B9C33242B3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4C97CE-191D-A46C-B709-63EF5D3365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4B1AE-7F45-4D2D-A34F-DA245737C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84793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68447D5-8244-F504-8909-495BD50002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FDE2B4-3A62-A93A-72BA-940660D29A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26630A-88EF-C65F-A696-A03634ED6B7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CD2068D-A75F-474F-B16C-DE4D13AE3CF1}" type="datetimeFigureOut">
              <a:rPr lang="en-US" smtClean="0"/>
              <a:t>2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7B795E-1BDE-BBD0-2ACA-365B8926B87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BC2DD6-20A0-F85F-0335-134626B95C1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E84B1AE-7F45-4D2D-A34F-DA245737C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57603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MP4"/><Relationship Id="rId7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6.xml"/><Relationship Id="rId4" Type="http://schemas.openxmlformats.org/officeDocument/2006/relationships/video" Target="../media/media2.MP4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6.xml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6.xml"/><Relationship Id="rId2" Type="http://schemas.openxmlformats.org/officeDocument/2006/relationships/video" Target="../media/media4.mp4"/><Relationship Id="rId1" Type="http://schemas.microsoft.com/office/2007/relationships/media" Target="../media/media4.mp4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media" Target="../media/media6.MP4"/><Relationship Id="rId7" Type="http://schemas.openxmlformats.org/officeDocument/2006/relationships/image" Target="../media/image6.png"/><Relationship Id="rId2" Type="http://schemas.openxmlformats.org/officeDocument/2006/relationships/video" Target="../media/media5.mp4"/><Relationship Id="rId1" Type="http://schemas.microsoft.com/office/2007/relationships/media" Target="../media/media5.mp4"/><Relationship Id="rId6" Type="http://schemas.openxmlformats.org/officeDocument/2006/relationships/image" Target="../media/image5.png"/><Relationship Id="rId5" Type="http://schemas.openxmlformats.org/officeDocument/2006/relationships/slideLayout" Target="../slideLayouts/slideLayout6.xml"/><Relationship Id="rId4" Type="http://schemas.openxmlformats.org/officeDocument/2006/relationships/video" Target="../media/media6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30">
            <a:hlinkClick r:id="" action="ppaction://media"/>
            <a:extLst>
              <a:ext uri="{FF2B5EF4-FFF2-40B4-BE49-F238E27FC236}">
                <a16:creationId xmlns:a16="http://schemas.microsoft.com/office/drawing/2014/main" id="{F2A485BE-4856-BD10-EE69-5CA535B727B3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rcRect l="17796" r="17667"/>
          <a:stretch/>
        </p:blipFill>
        <p:spPr>
          <a:xfrm>
            <a:off x="6184920" y="1653744"/>
            <a:ext cx="5600705" cy="4114800"/>
          </a:xfrm>
          <a:prstGeom prst="rect">
            <a:avLst/>
          </a:prstGeom>
        </p:spPr>
      </p:pic>
      <p:sp>
        <p:nvSpPr>
          <p:cNvPr id="6" name="Title 1">
            <a:extLst>
              <a:ext uri="{FF2B5EF4-FFF2-40B4-BE49-F238E27FC236}">
                <a16:creationId xmlns:a16="http://schemas.microsoft.com/office/drawing/2014/main" id="{2A8E855B-5DE7-98FB-8D12-19F7A435DB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67208" y="235821"/>
            <a:ext cx="10391918" cy="1325563"/>
          </a:xfrm>
        </p:spPr>
        <p:txBody>
          <a:bodyPr>
            <a:normAutofit/>
          </a:bodyPr>
          <a:lstStyle/>
          <a:p>
            <a:r>
              <a:rPr lang="en-US" sz="1800" b="1" dirty="0"/>
              <a:t>Supplementary Video 1:</a:t>
            </a:r>
            <a:r>
              <a:rPr lang="en-US" sz="1400" kern="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 Torrential (5+) TR at baseline, by (A) RV inflow view on TTE; and (B) 2D x-plane ICE color flow imaging</a:t>
            </a:r>
            <a:endParaRPr lang="en-US" sz="1400" b="1" dirty="0"/>
          </a:p>
        </p:txBody>
      </p:sp>
      <p:pic>
        <p:nvPicPr>
          <p:cNvPr id="2" name="Severe TR pre-TriClip - TTE">
            <a:hlinkClick r:id="" action="ppaction://media"/>
            <a:extLst>
              <a:ext uri="{FF2B5EF4-FFF2-40B4-BE49-F238E27FC236}">
                <a16:creationId xmlns:a16="http://schemas.microsoft.com/office/drawing/2014/main" id="{F63B4975-0927-0B38-457F-F47CB74C1E43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406375" y="1653744"/>
            <a:ext cx="5486400" cy="41148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4ABF286-5F28-26EF-0942-870AC15D9C63}"/>
              </a:ext>
            </a:extLst>
          </p:cNvPr>
          <p:cNvSpPr txBox="1"/>
          <p:nvPr/>
        </p:nvSpPr>
        <p:spPr>
          <a:xfrm>
            <a:off x="314476" y="1348064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A0701BB-48DF-58C3-795D-F4D81BA1938A}"/>
              </a:ext>
            </a:extLst>
          </p:cNvPr>
          <p:cNvSpPr txBox="1"/>
          <p:nvPr/>
        </p:nvSpPr>
        <p:spPr>
          <a:xfrm>
            <a:off x="6071007" y="1344818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87328013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866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1866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2499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0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16" repeatCount="indefinite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08FAEF1-A228-5E9E-9E2F-7D2A5CA7253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53">
            <a:hlinkClick r:id="" action="ppaction://media"/>
            <a:extLst>
              <a:ext uri="{FF2B5EF4-FFF2-40B4-BE49-F238E27FC236}">
                <a16:creationId xmlns:a16="http://schemas.microsoft.com/office/drawing/2014/main" id="{A4CA0805-4443-0C50-ED90-952240C69FD2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rcRect l="17796" r="18538"/>
          <a:stretch/>
        </p:blipFill>
        <p:spPr>
          <a:xfrm>
            <a:off x="2880673" y="1495111"/>
            <a:ext cx="6384467" cy="4754880"/>
          </a:xfrm>
          <a:prstGeom prst="rect">
            <a:avLst/>
          </a:prstGeom>
        </p:spPr>
      </p:pic>
      <p:sp>
        <p:nvSpPr>
          <p:cNvPr id="6" name="Title 1">
            <a:extLst>
              <a:ext uri="{FF2B5EF4-FFF2-40B4-BE49-F238E27FC236}">
                <a16:creationId xmlns:a16="http://schemas.microsoft.com/office/drawing/2014/main" id="{D06334DF-69E1-AA89-FC22-F12A61474B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55889"/>
            <a:ext cx="10515600" cy="1325563"/>
          </a:xfrm>
        </p:spPr>
        <p:txBody>
          <a:bodyPr>
            <a:normAutofit/>
          </a:bodyPr>
          <a:lstStyle/>
          <a:p>
            <a:r>
              <a:rPr lang="en-US" sz="1800" b="1" dirty="0"/>
              <a:t>Supplementary Video 2:</a:t>
            </a:r>
            <a:r>
              <a:rPr lang="en-US" sz="1400" kern="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 </a:t>
            </a:r>
            <a:r>
              <a:rPr lang="en-US" sz="14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Mid-leaflet alignment of </a:t>
            </a:r>
            <a:r>
              <a:rPr lang="en-US" sz="140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1</a:t>
            </a:r>
            <a:r>
              <a:rPr lang="en-US" sz="1400" baseline="3000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t</a:t>
            </a:r>
            <a:r>
              <a:rPr lang="en-US" sz="140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400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TriClip</a:t>
            </a:r>
            <a:r>
              <a:rPr lang="en-US" sz="14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XTW device over </a:t>
            </a:r>
            <a:r>
              <a:rPr lang="en-US" sz="1400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osteroseptal</a:t>
            </a:r>
            <a:r>
              <a:rPr lang="en-US" sz="14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coaptation gap, in MPR</a:t>
            </a:r>
            <a:br>
              <a:rPr lang="en-US" sz="18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</a:b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51485099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10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39D2C40-2DFE-38A8-9B11-7FC4A617D27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108">
            <a:hlinkClick r:id="" action="ppaction://media"/>
            <a:extLst>
              <a:ext uri="{FF2B5EF4-FFF2-40B4-BE49-F238E27FC236}">
                <a16:creationId xmlns:a16="http://schemas.microsoft.com/office/drawing/2014/main" id="{C0324EB2-9174-C3EC-8E9F-4A95B7C0E912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rcRect l="17602" r="17860"/>
          <a:stretch/>
        </p:blipFill>
        <p:spPr>
          <a:xfrm>
            <a:off x="2879322" y="1497432"/>
            <a:ext cx="6471927" cy="4754880"/>
          </a:xfrm>
          <a:prstGeom prst="rect">
            <a:avLst/>
          </a:prstGeom>
        </p:spPr>
      </p:pic>
      <p:sp>
        <p:nvSpPr>
          <p:cNvPr id="6" name="Title 1">
            <a:extLst>
              <a:ext uri="{FF2B5EF4-FFF2-40B4-BE49-F238E27FC236}">
                <a16:creationId xmlns:a16="http://schemas.microsoft.com/office/drawing/2014/main" id="{03270FD9-9E72-2C96-E21B-7CB1539291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10492" y="282001"/>
            <a:ext cx="10515600" cy="1325563"/>
          </a:xfrm>
        </p:spPr>
        <p:txBody>
          <a:bodyPr>
            <a:normAutofit/>
          </a:bodyPr>
          <a:lstStyle/>
          <a:p>
            <a:r>
              <a:rPr lang="en-US" sz="1800" b="1" dirty="0"/>
              <a:t>Supplementary Video 3:  </a:t>
            </a:r>
            <a:r>
              <a:rPr lang="en-US" sz="1400" kern="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ommissural alignment of 2</a:t>
            </a:r>
            <a:r>
              <a:rPr lang="en-US" sz="1400" kern="0" baseline="300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d</a:t>
            </a:r>
            <a:r>
              <a:rPr lang="en-US" sz="1400" kern="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400" kern="0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TriClip</a:t>
            </a:r>
            <a:r>
              <a:rPr lang="en-US" sz="1400" kern="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XTW device over </a:t>
            </a:r>
            <a:r>
              <a:rPr lang="en-US" sz="1400" kern="0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osteroseptal</a:t>
            </a:r>
            <a:r>
              <a:rPr lang="en-US" sz="1400" kern="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coaptation gap, in MPR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40580411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293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51A37D7-DD37-4E94-D5D9-F1AA7B8AC9D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134">
            <a:hlinkClick r:id="" action="ppaction://media"/>
            <a:extLst>
              <a:ext uri="{FF2B5EF4-FFF2-40B4-BE49-F238E27FC236}">
                <a16:creationId xmlns:a16="http://schemas.microsoft.com/office/drawing/2014/main" id="{1283302E-F545-1D72-4934-EDB181903A4E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rcRect l="18184" r="17568"/>
          <a:stretch/>
        </p:blipFill>
        <p:spPr>
          <a:xfrm>
            <a:off x="411157" y="1672219"/>
            <a:ext cx="5575478" cy="4114800"/>
          </a:xfrm>
          <a:prstGeom prst="rect">
            <a:avLst/>
          </a:prstGeom>
        </p:spPr>
      </p:pic>
      <p:sp>
        <p:nvSpPr>
          <p:cNvPr id="6" name="Title 1">
            <a:extLst>
              <a:ext uri="{FF2B5EF4-FFF2-40B4-BE49-F238E27FC236}">
                <a16:creationId xmlns:a16="http://schemas.microsoft.com/office/drawing/2014/main" id="{0F78893E-6220-A92A-BAB4-57598AC8B0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91899" y="365125"/>
            <a:ext cx="11933381" cy="1325563"/>
          </a:xfrm>
        </p:spPr>
        <p:txBody>
          <a:bodyPr>
            <a:normAutofit/>
          </a:bodyPr>
          <a:lstStyle/>
          <a:p>
            <a:r>
              <a:rPr lang="en-US" sz="1800" b="1" dirty="0"/>
              <a:t>Supplementary Video 4:  </a:t>
            </a:r>
            <a:r>
              <a:rPr lang="en-US" sz="14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Moderate (2+) residual TR, by (A) 2D x-plane ICE color flow imaging, at case end; and (B) RV inflow view on TTE, next day </a:t>
            </a:r>
            <a:br>
              <a:rPr lang="en-US" sz="14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</a:br>
            <a:endParaRPr lang="en-US" sz="1400" b="1" dirty="0"/>
          </a:p>
        </p:txBody>
      </p:sp>
      <p:pic>
        <p:nvPicPr>
          <p:cNvPr id="3" name="Severe TR post-TriClip - TTE">
            <a:hlinkClick r:id="" action="ppaction://media"/>
            <a:extLst>
              <a:ext uri="{FF2B5EF4-FFF2-40B4-BE49-F238E27FC236}">
                <a16:creationId xmlns:a16="http://schemas.microsoft.com/office/drawing/2014/main" id="{B78E0DD1-C6DE-5B00-2532-96EC238AEDEA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6205367" y="1672219"/>
            <a:ext cx="5486400" cy="41148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A1703FE-B76A-129E-7FD8-29958AAF20A1}"/>
              </a:ext>
            </a:extLst>
          </p:cNvPr>
          <p:cNvSpPr txBox="1"/>
          <p:nvPr/>
        </p:nvSpPr>
        <p:spPr>
          <a:xfrm>
            <a:off x="314476" y="1366543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F48FEA5-DF23-41D0-613B-D44E6CF736B2}"/>
              </a:ext>
            </a:extLst>
          </p:cNvPr>
          <p:cNvSpPr txBox="1"/>
          <p:nvPr/>
        </p:nvSpPr>
        <p:spPr>
          <a:xfrm>
            <a:off x="6089479" y="1363297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27596840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125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2125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307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0" repeatCount="indefinite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16" repeatCount="indefinite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9</TotalTime>
  <Words>112</Words>
  <Application>Microsoft Office PowerPoint</Application>
  <PresentationFormat>Widescreen</PresentationFormat>
  <Paragraphs>8</Paragraphs>
  <Slides>4</Slides>
  <Notes>0</Notes>
  <HiddenSlides>0</HiddenSlides>
  <MMClips>6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ptos</vt:lpstr>
      <vt:lpstr>Aptos Display</vt:lpstr>
      <vt:lpstr>Arial</vt:lpstr>
      <vt:lpstr>Office Theme</vt:lpstr>
      <vt:lpstr>Supplementary Video 1:  Torrential (5+) TR at baseline, by (A) RV inflow view on TTE; and (B) 2D x-plane ICE color flow imaging</vt:lpstr>
      <vt:lpstr>Supplementary Video 2:  Mid-leaflet alignment of 1st  TriClip XTW device over posteroseptal coaptation gap, in MPR </vt:lpstr>
      <vt:lpstr>Supplementary Video 3:  Commissural alignment of 2nd TriClip XTW device over posteroseptal coaptation gap, in MPR</vt:lpstr>
      <vt:lpstr>Supplementary Video 4:  Moderate (2+) residual TR, by (A) 2D x-plane ICE color flow imaging, at case end; and (B) RV inflow view on TTE, next day 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rown, Lynne</dc:creator>
  <cp:lastModifiedBy>Hoffman, Scott J</cp:lastModifiedBy>
  <cp:revision>12</cp:revision>
  <dcterms:created xsi:type="dcterms:W3CDTF">2025-01-14T02:30:31Z</dcterms:created>
  <dcterms:modified xsi:type="dcterms:W3CDTF">2025-02-19T21:17:50Z</dcterms:modified>
</cp:coreProperties>
</file>